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3" r:id="rId1"/>
  </p:sldMasterIdLst>
  <p:notesMasterIdLst>
    <p:notesMasterId r:id="rId7"/>
  </p:notesMasterIdLst>
  <p:sldIdLst>
    <p:sldId id="634" r:id="rId2"/>
    <p:sldId id="633" r:id="rId3"/>
    <p:sldId id="630" r:id="rId4"/>
    <p:sldId id="631" r:id="rId5"/>
    <p:sldId id="63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24AFE"/>
    <a:srgbClr val="FB3A35"/>
    <a:srgbClr val="969696"/>
    <a:srgbClr val="000000"/>
    <a:srgbClr val="CC3300"/>
    <a:srgbClr val="11111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43" autoAdjust="0"/>
    <p:restoredTop sz="81273" autoAdjust="0"/>
  </p:normalViewPr>
  <p:slideViewPr>
    <p:cSldViewPr snapToGrid="0">
      <p:cViewPr varScale="1">
        <p:scale>
          <a:sx n="60" d="100"/>
          <a:sy n="60" d="100"/>
        </p:scale>
        <p:origin x="930" y="60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16008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796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F84B52-173A-4862-AD02-7727C091D3EC}" type="datetimeFigureOut">
              <a:rPr lang="en-US" smtClean="0"/>
              <a:pPr/>
              <a:t>11/22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4D0652-18D3-45A4-94CE-404FE265028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99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ry figure</a:t>
            </a:r>
            <a:r>
              <a:rPr lang="en-US" baseline="0" dirty="0" smtClean="0"/>
              <a:t> 1</a:t>
            </a:r>
            <a:r>
              <a:rPr lang="en-US" dirty="0" smtClean="0"/>
              <a:t>: 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e- and post-senescence period, was determined by measuring the chlorophyll content. Red arrow indicate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mid line between pre and post senescence period, determined based on chlorophyll content measurement.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ample interval indicates number of week and CCI indicates relative amount of chlorophyll content in that particular weight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4D0652-18D3-45A4-94CE-404FE2650287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77545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Supplementary figure</a:t>
            </a:r>
            <a:r>
              <a:rPr lang="en-US" baseline="0" dirty="0" smtClean="0"/>
              <a:t> </a:t>
            </a:r>
            <a:r>
              <a:rPr lang="en-US" baseline="0" dirty="0" smtClean="0"/>
              <a:t>2</a:t>
            </a:r>
            <a:r>
              <a:rPr lang="en-US" dirty="0" smtClean="0"/>
              <a:t>: </a:t>
            </a:r>
            <a:r>
              <a:rPr lang="en-US" dirty="0" smtClean="0"/>
              <a:t>Proposed model of sugar metabolism</a:t>
            </a:r>
            <a:r>
              <a:rPr lang="en-US" baseline="0" dirty="0" smtClean="0"/>
              <a:t> towards Hexoses and sucrose formation during the senescence process which signals for early floral development, translocation of sugars from source to sink, and early senescence. We found </a:t>
            </a:r>
            <a:r>
              <a:rPr lang="en-US" baseline="0" dirty="0" err="1" smtClean="0"/>
              <a:t>upregulation</a:t>
            </a:r>
            <a:r>
              <a:rPr lang="en-US" baseline="0" dirty="0" smtClean="0"/>
              <a:t> of 5 proteins shown above, during the process of senescence whereas 3-proteins: </a:t>
            </a:r>
            <a:r>
              <a:rPr lang="el-GR" sz="1200" dirty="0" smtClean="0"/>
              <a:t>β</a:t>
            </a:r>
            <a:r>
              <a:rPr lang="en-US" sz="1200" dirty="0" smtClean="0"/>
              <a:t>-</a:t>
            </a:r>
            <a:r>
              <a:rPr lang="en-US" sz="1200" dirty="0" err="1" smtClean="0"/>
              <a:t>Ketoadepyl</a:t>
            </a:r>
            <a:r>
              <a:rPr lang="en-US" sz="1200" dirty="0" smtClean="0"/>
              <a:t> CoA </a:t>
            </a:r>
            <a:r>
              <a:rPr lang="en-US" sz="1200" dirty="0" err="1" smtClean="0"/>
              <a:t>thiolase</a:t>
            </a:r>
            <a:r>
              <a:rPr lang="en-US" sz="1200" dirty="0" smtClean="0"/>
              <a:t>, Cysteine protease,</a:t>
            </a:r>
            <a:r>
              <a:rPr lang="en-US" sz="1200" baseline="0" dirty="0" smtClean="0"/>
              <a:t> and </a:t>
            </a:r>
            <a:r>
              <a:rPr lang="en-US" sz="1200" dirty="0" smtClean="0"/>
              <a:t>Sucrose phosphate synthase</a:t>
            </a:r>
            <a:r>
              <a:rPr lang="en-US" sz="1200" baseline="0" dirty="0" smtClean="0"/>
              <a:t> were constitutively </a:t>
            </a:r>
            <a:r>
              <a:rPr lang="en-US" sz="1200" baseline="0" dirty="0" err="1" smtClean="0"/>
              <a:t>downregulated</a:t>
            </a:r>
            <a:r>
              <a:rPr lang="en-US" sz="1200" baseline="0" dirty="0" smtClean="0"/>
              <a:t> in late senescing PCG compared to early senescing when analyzed before the senescence.  </a:t>
            </a:r>
            <a:endParaRPr lang="en-US" sz="12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C40946-76F0-48E6-BA25-CAAEDF00005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1155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ry figure</a:t>
            </a:r>
            <a:r>
              <a:rPr lang="en-US" baseline="0" dirty="0" smtClean="0"/>
              <a:t> </a:t>
            </a:r>
            <a:r>
              <a:rPr lang="en-US" baseline="0" dirty="0" smtClean="0"/>
              <a:t>3</a:t>
            </a:r>
            <a:r>
              <a:rPr lang="en-US" dirty="0" smtClean="0"/>
              <a:t>: </a:t>
            </a:r>
            <a:r>
              <a:rPr lang="en-US" dirty="0" smtClean="0"/>
              <a:t>Constitutive</a:t>
            </a:r>
            <a:r>
              <a:rPr lang="en-US" baseline="0" dirty="0" smtClean="0"/>
              <a:t> overexpression of three proteins, in “late senescing cultivar” of PCG compared to “early senescing” cultivar, that are involved in photosystems splitting the water and fixing the carbon. Three proteins </a:t>
            </a:r>
            <a:r>
              <a:rPr lang="en-US" baseline="0" dirty="0" err="1" smtClean="0"/>
              <a:t>upregulated</a:t>
            </a:r>
            <a:r>
              <a:rPr lang="en-US" baseline="0" dirty="0" smtClean="0"/>
              <a:t> were Oxygen evolving enhancer protein of photosystem II, </a:t>
            </a:r>
            <a:r>
              <a:rPr lang="en-US" baseline="0" dirty="0" err="1" smtClean="0"/>
              <a:t>Ferrodoxin</a:t>
            </a:r>
            <a:r>
              <a:rPr lang="en-US" baseline="0" dirty="0" smtClean="0"/>
              <a:t>-NADP-reductase, and </a:t>
            </a:r>
            <a:r>
              <a:rPr lang="el-GR" baseline="0" dirty="0" smtClean="0"/>
              <a:t>α</a:t>
            </a:r>
            <a:r>
              <a:rPr lang="en-US" baseline="0" dirty="0" smtClean="0"/>
              <a:t>-subunit &amp; </a:t>
            </a:r>
            <a:r>
              <a:rPr lang="el-GR" baseline="0" dirty="0" smtClean="0"/>
              <a:t>β</a:t>
            </a:r>
            <a:r>
              <a:rPr lang="en-US" baseline="0" dirty="0" smtClean="0"/>
              <a:t>-subunit of ATP synthase. Fig of photosynthesis reproduced from KEGG reference pathway (http://www.genome.jp/kegg/pathway/map/map00195.html)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C40946-76F0-48E6-BA25-CAAEDF00005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6318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ry figure</a:t>
            </a:r>
            <a:r>
              <a:rPr lang="en-US" baseline="0" dirty="0" smtClean="0"/>
              <a:t> </a:t>
            </a:r>
            <a:r>
              <a:rPr lang="en-US" baseline="0" dirty="0" smtClean="0"/>
              <a:t>4 </a:t>
            </a:r>
            <a:r>
              <a:rPr lang="en-US" baseline="0" dirty="0" smtClean="0"/>
              <a:t>: Constitutively overexpressed proteins in “late senescing” cultivar of PCG compared to “early senescing” cultivar, that catalyze various steps in Calvin cycle. Overexpression of 3 enzymes that catalyze the vital rate limiting steps are marked with red arrows. Three different enzymes </a:t>
            </a:r>
            <a:r>
              <a:rPr lang="en-US" baseline="0" dirty="0" err="1" smtClean="0"/>
              <a:t>upregulated</a:t>
            </a:r>
            <a:r>
              <a:rPr lang="en-US" baseline="0" dirty="0" smtClean="0"/>
              <a:t> are : </a:t>
            </a:r>
          </a:p>
          <a:p>
            <a:r>
              <a:rPr lang="en-US" baseline="0" dirty="0" smtClean="0"/>
              <a:t>1= Fructose </a:t>
            </a:r>
            <a:r>
              <a:rPr lang="en-US" baseline="0" dirty="0" err="1" smtClean="0"/>
              <a:t>bishphsphate</a:t>
            </a:r>
            <a:r>
              <a:rPr lang="en-US" baseline="0" dirty="0" smtClean="0"/>
              <a:t> aldolase; 2=</a:t>
            </a:r>
            <a:r>
              <a:rPr lang="en-US" baseline="0" dirty="0" err="1" smtClean="0"/>
              <a:t>Transketolase</a:t>
            </a:r>
            <a:r>
              <a:rPr lang="en-US" baseline="0" dirty="0" smtClean="0"/>
              <a:t>; 3=Sedoheptulose-1,7-bisphosphatas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C40946-76F0-48E6-BA25-CAAEDF00005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10744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ry figure</a:t>
            </a:r>
            <a:r>
              <a:rPr lang="en-US" baseline="0" dirty="0" smtClean="0"/>
              <a:t> </a:t>
            </a:r>
            <a:r>
              <a:rPr lang="en-US" baseline="0" dirty="0" smtClean="0"/>
              <a:t>5</a:t>
            </a:r>
            <a:r>
              <a:rPr lang="en-US" dirty="0" smtClean="0"/>
              <a:t> </a:t>
            </a:r>
            <a:r>
              <a:rPr lang="en-US" dirty="0" smtClean="0"/>
              <a:t>: Oxidative phosphorylation pathway showing upregulation of complex II,</a:t>
            </a:r>
            <a:r>
              <a:rPr lang="en-US" baseline="0" dirty="0" smtClean="0"/>
              <a:t> and complex IV as observed in our study. </a:t>
            </a:r>
            <a:r>
              <a:rPr lang="en-US" baseline="0" dirty="0" err="1" smtClean="0"/>
              <a:t>Upregulation</a:t>
            </a:r>
            <a:r>
              <a:rPr lang="en-US" baseline="0" dirty="0" smtClean="0"/>
              <a:t> of complexes in oxidative phosphorylation may contribute to increase the ROS level, thus signaling the expression of senescence associated genes. Constitutive </a:t>
            </a:r>
            <a:r>
              <a:rPr lang="en-US" baseline="0" dirty="0" err="1" smtClean="0"/>
              <a:t>upregulation</a:t>
            </a:r>
            <a:r>
              <a:rPr lang="en-US" baseline="0" dirty="0" smtClean="0"/>
              <a:t> of complex IV was observed in “early senescing” cultivar of PCG compared to “late senescing” cultivar. </a:t>
            </a:r>
            <a:r>
              <a:rPr lang="en-US" baseline="0" dirty="0" err="1" smtClean="0"/>
              <a:t>Upregulation</a:t>
            </a:r>
            <a:r>
              <a:rPr lang="en-US" baseline="0" dirty="0" smtClean="0"/>
              <a:t> of components in oxidative phosphorylation contributes to produce ROS and signal for expression of senescence associated genes. Fig of oxidative phosphorylation reproduced from KEGG pathway (http://www.genome.jp/kegg/pathway/map/map00190.html)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C40946-76F0-48E6-BA25-CAAEDF00005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7686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1" y="3602039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3384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4480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6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6"/>
            <a:ext cx="773429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854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3042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70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45672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0992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3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5687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89835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1246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8976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4335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1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7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554F6-C4E0-4CC7-BA33-B9CF38FBD719}" type="datetimeFigureOut">
              <a:rPr lang="en-US" smtClean="0"/>
              <a:pPr/>
              <a:t>11/22/201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1" y="6356357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7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F85E25-08BE-4CAE-B8D5-3B814AE459AA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4440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4" r:id="rId1"/>
    <p:sldLayoutId id="2147483715" r:id="rId2"/>
    <p:sldLayoutId id="2147483716" r:id="rId3"/>
    <p:sldLayoutId id="2147483717" r:id="rId4"/>
    <p:sldLayoutId id="2147483718" r:id="rId5"/>
    <p:sldLayoutId id="2147483719" r:id="rId6"/>
    <p:sldLayoutId id="2147483720" r:id="rId7"/>
    <p:sldLayoutId id="2147483721" r:id="rId8"/>
    <p:sldLayoutId id="2147483722" r:id="rId9"/>
    <p:sldLayoutId id="2147483723" r:id="rId10"/>
    <p:sldLayoutId id="214748372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ight Arrow 4"/>
          <p:cNvSpPr/>
          <p:nvPr/>
        </p:nvSpPr>
        <p:spPr>
          <a:xfrm>
            <a:off x="1664310" y="1696876"/>
            <a:ext cx="8499809" cy="568391"/>
          </a:xfrm>
          <a:prstGeom prst="rightArrow">
            <a:avLst/>
          </a:prstGeom>
          <a:gradFill flip="none" rotWithShape="1">
            <a:gsLst>
              <a:gs pos="0">
                <a:srgbClr val="00B050">
                  <a:shade val="30000"/>
                  <a:satMod val="115000"/>
                </a:srgbClr>
              </a:gs>
              <a:gs pos="50000">
                <a:srgbClr val="00B050">
                  <a:shade val="67500"/>
                  <a:satMod val="115000"/>
                </a:srgbClr>
              </a:gs>
              <a:gs pos="100000">
                <a:srgbClr val="00B050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1664305" y="1669373"/>
            <a:ext cx="0" cy="1033438"/>
          </a:xfrm>
          <a:prstGeom prst="line">
            <a:avLst/>
          </a:prstGeom>
          <a:ln w="381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117912" y="2702812"/>
            <a:ext cx="1099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Spring </a:t>
            </a:r>
            <a:endParaRPr lang="en-US" b="1" dirty="0">
              <a:solidFill>
                <a:prstClr val="black"/>
              </a:solidFill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6207309" y="1663543"/>
            <a:ext cx="2859" cy="557365"/>
          </a:xfrm>
          <a:prstGeom prst="line">
            <a:avLst/>
          </a:prstGeom>
          <a:ln w="38100"/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733907" y="2183169"/>
            <a:ext cx="2278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Pre-Senescence</a:t>
            </a:r>
            <a:endParaRPr lang="en-US" b="1" dirty="0">
              <a:solidFill>
                <a:prstClr val="black"/>
              </a:solidFill>
            </a:endParaRPr>
          </a:p>
        </p:txBody>
      </p:sp>
      <p:cxnSp>
        <p:nvCxnSpPr>
          <p:cNvPr id="21" name="Straight Connector 20"/>
          <p:cNvCxnSpPr/>
          <p:nvPr/>
        </p:nvCxnSpPr>
        <p:spPr>
          <a:xfrm>
            <a:off x="8192803" y="1653540"/>
            <a:ext cx="11417" cy="578383"/>
          </a:xfrm>
          <a:prstGeom prst="line">
            <a:avLst/>
          </a:prstGeom>
          <a:ln w="28575"/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236264" y="2216933"/>
            <a:ext cx="1992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Post-Senescence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9437020" y="2294052"/>
            <a:ext cx="1099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Winter</a:t>
            </a:r>
            <a:endParaRPr lang="en-US" b="1" dirty="0">
              <a:solidFill>
                <a:prstClr val="black"/>
              </a:solidFill>
            </a:endParaRPr>
          </a:p>
        </p:txBody>
      </p:sp>
      <p:pic>
        <p:nvPicPr>
          <p:cNvPr id="13" name="Picture 12"/>
          <p:cNvPicPr/>
          <p:nvPr/>
        </p:nvPicPr>
        <p:blipFill rotWithShape="1">
          <a:blip r:embed="rId3"/>
          <a:srcRect t="50000"/>
          <a:stretch/>
        </p:blipFill>
        <p:spPr>
          <a:xfrm>
            <a:off x="28740" y="3441560"/>
            <a:ext cx="12190809" cy="3220499"/>
          </a:xfrm>
          <a:prstGeom prst="rect">
            <a:avLst/>
          </a:prstGeom>
          <a:ln>
            <a:noFill/>
          </a:ln>
        </p:spPr>
      </p:pic>
      <p:sp>
        <p:nvSpPr>
          <p:cNvPr id="3" name="TextBox 2"/>
          <p:cNvSpPr txBox="1"/>
          <p:nvPr/>
        </p:nvSpPr>
        <p:spPr>
          <a:xfrm>
            <a:off x="4911629" y="1208308"/>
            <a:ext cx="2653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Before 3</a:t>
            </a:r>
            <a:r>
              <a:rPr lang="en-US" b="1" baseline="30000" dirty="0" smtClean="0">
                <a:solidFill>
                  <a:prstClr val="black"/>
                </a:solidFill>
              </a:rPr>
              <a:t>rd</a:t>
            </a:r>
            <a:r>
              <a:rPr lang="en-US" b="1" dirty="0" smtClean="0">
                <a:solidFill>
                  <a:prstClr val="black"/>
                </a:solidFill>
              </a:rPr>
              <a:t> week of August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979729" y="2454751"/>
            <a:ext cx="2480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Last week of September</a:t>
            </a:r>
            <a:endParaRPr lang="en-US" b="1" dirty="0">
              <a:solidFill>
                <a:prstClr val="black"/>
              </a:solidFill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2481943" y="3690257"/>
            <a:ext cx="0" cy="1361550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8610600" y="3499340"/>
            <a:ext cx="0" cy="1034978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647752" y="320528"/>
            <a:ext cx="92020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prstClr val="black"/>
                </a:solidFill>
              </a:rPr>
              <a:t>Pre-senescence and post-senescence stages of SG and PCG based on chlorophyll </a:t>
            </a:r>
            <a:r>
              <a:rPr lang="en-US" sz="2000" b="1" dirty="0">
                <a:solidFill>
                  <a:prstClr val="black"/>
                </a:solidFill>
              </a:rPr>
              <a:t>d</a:t>
            </a:r>
            <a:r>
              <a:rPr lang="en-US" sz="2000" b="1" dirty="0" smtClean="0">
                <a:solidFill>
                  <a:prstClr val="black"/>
                </a:solidFill>
              </a:rPr>
              <a:t>ata</a:t>
            </a:r>
            <a:endParaRPr lang="en-US" sz="2000" b="1" dirty="0">
              <a:solidFill>
                <a:prstClr val="black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40871" y="3505594"/>
            <a:ext cx="1866004" cy="369332"/>
          </a:xfrm>
          <a:prstGeom prst="rect">
            <a:avLst/>
          </a:prstGeom>
          <a:solidFill>
            <a:srgbClr val="00B05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Pre-Senescence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24" name="Right Arrow 23"/>
          <p:cNvSpPr/>
          <p:nvPr/>
        </p:nvSpPr>
        <p:spPr>
          <a:xfrm>
            <a:off x="8045841" y="1702317"/>
            <a:ext cx="2123715" cy="568391"/>
          </a:xfrm>
          <a:prstGeom prst="rightArrow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600436" y="3505594"/>
            <a:ext cx="1992525" cy="369332"/>
          </a:xfrm>
          <a:prstGeom prst="rect">
            <a:avLst/>
          </a:prstGeom>
          <a:solidFill>
            <a:srgbClr val="FFC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Post-Senescence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745452" y="3527750"/>
            <a:ext cx="1992525" cy="369332"/>
          </a:xfrm>
          <a:prstGeom prst="rect">
            <a:avLst/>
          </a:prstGeom>
          <a:solidFill>
            <a:srgbClr val="FFC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Post-Senescence</a:t>
            </a:r>
            <a:endParaRPr lang="en-US" b="1" dirty="0">
              <a:solidFill>
                <a:prstClr val="black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417126" y="3505594"/>
            <a:ext cx="1887271" cy="369332"/>
          </a:xfrm>
          <a:prstGeom prst="rect">
            <a:avLst/>
          </a:prstGeom>
          <a:solidFill>
            <a:srgbClr val="00B05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prstClr val="black"/>
                </a:solidFill>
              </a:rPr>
              <a:t>Pre-Senescence</a:t>
            </a:r>
            <a:endParaRPr lang="en-US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137321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135051"/>
    </mc:Choice>
    <mc:Fallback xmlns="">
      <p:transition spd="slow" advTm="135051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31832" y="335405"/>
            <a:ext cx="8947417" cy="6358965"/>
            <a:chOff x="153552" y="381125"/>
            <a:chExt cx="8947417" cy="6358965"/>
          </a:xfrm>
        </p:grpSpPr>
        <p:sp>
          <p:nvSpPr>
            <p:cNvPr id="48" name="Rectangle 47"/>
            <p:cNvSpPr/>
            <p:nvPr/>
          </p:nvSpPr>
          <p:spPr>
            <a:xfrm>
              <a:off x="153552" y="6360528"/>
              <a:ext cx="1962076" cy="37956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err="1" smtClean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upregulation</a:t>
              </a:r>
              <a:endParaRPr lang="en-US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Oval 12"/>
            <p:cNvSpPr/>
            <p:nvPr/>
          </p:nvSpPr>
          <p:spPr>
            <a:xfrm>
              <a:off x="2018581" y="1242210"/>
              <a:ext cx="4779034" cy="1239322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Rounded Rectangle 3"/>
            <p:cNvSpPr/>
            <p:nvPr/>
          </p:nvSpPr>
          <p:spPr>
            <a:xfrm>
              <a:off x="2115628" y="381125"/>
              <a:ext cx="2440555" cy="336430"/>
            </a:xfrm>
            <a:prstGeom prst="roundRect">
              <a:avLst/>
            </a:prstGeom>
            <a:solidFill>
              <a:schemeClr val="accent1">
                <a:lumMod val="60000"/>
                <a:lumOff val="40000"/>
              </a:schemeClr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l-GR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sz="14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etoadepyl</a:t>
              </a:r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oA </a:t>
              </a:r>
              <a:r>
                <a:rPr lang="en-US" sz="14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hiolase</a:t>
              </a:r>
              <a:endPara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ounded Rectangle 4"/>
            <p:cNvSpPr/>
            <p:nvPr/>
          </p:nvSpPr>
          <p:spPr>
            <a:xfrm>
              <a:off x="2253726" y="1620742"/>
              <a:ext cx="1886953" cy="336430"/>
            </a:xfrm>
            <a:prstGeom prst="roundRect">
              <a:avLst/>
            </a:prstGeom>
            <a:solidFill>
              <a:schemeClr val="accent2"/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onitase</a:t>
              </a:r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4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ydratase</a:t>
              </a:r>
              <a:endPara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ounded Rectangle 5"/>
            <p:cNvSpPr/>
            <p:nvPr/>
          </p:nvSpPr>
          <p:spPr>
            <a:xfrm>
              <a:off x="4370464" y="1624964"/>
              <a:ext cx="2142227" cy="336430"/>
            </a:xfrm>
            <a:prstGeom prst="roundRect">
              <a:avLst/>
            </a:prstGeom>
            <a:solidFill>
              <a:schemeClr val="accent2"/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ccinate dehydrogenase</a:t>
              </a:r>
              <a:endPara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ounded Rectangle 7"/>
            <p:cNvSpPr/>
            <p:nvPr/>
          </p:nvSpPr>
          <p:spPr>
            <a:xfrm>
              <a:off x="4829354" y="381420"/>
              <a:ext cx="1787106" cy="336430"/>
            </a:xfrm>
            <a:prstGeom prst="roundRect">
              <a:avLst/>
            </a:prstGeom>
            <a:solidFill>
              <a:srgbClr val="FF9393"/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ysteine protease</a:t>
              </a:r>
              <a:endPara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ounded Rectangle 8"/>
            <p:cNvSpPr/>
            <p:nvPr/>
          </p:nvSpPr>
          <p:spPr>
            <a:xfrm>
              <a:off x="3288024" y="4184658"/>
              <a:ext cx="2443503" cy="336430"/>
            </a:xfrm>
            <a:prstGeom prst="roundRect">
              <a:avLst/>
            </a:prstGeom>
            <a:solidFill>
              <a:schemeClr val="accent4">
                <a:lumMod val="75000"/>
              </a:schemeClr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crose phosphate synthase</a:t>
              </a:r>
              <a:endPara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ounded Rectangle 9"/>
            <p:cNvSpPr/>
            <p:nvPr/>
          </p:nvSpPr>
          <p:spPr>
            <a:xfrm>
              <a:off x="3406117" y="4832014"/>
              <a:ext cx="2165229" cy="642358"/>
            </a:xfrm>
            <a:prstGeom prst="roundRect">
              <a:avLst/>
            </a:prstGeom>
            <a:solidFill>
              <a:srgbClr val="00B0F0"/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pregulation</a:t>
              </a:r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in conversion of starch and glucose to sucrose</a:t>
              </a:r>
              <a:endPara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ounded Rectangle 11"/>
            <p:cNvSpPr/>
            <p:nvPr/>
          </p:nvSpPr>
          <p:spPr>
            <a:xfrm>
              <a:off x="3366044" y="5759795"/>
              <a:ext cx="2245373" cy="325046"/>
            </a:xfrm>
            <a:prstGeom prst="roundRect">
              <a:avLst/>
            </a:prstGeom>
            <a:solidFill>
              <a:srgbClr val="FFC000"/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ource to sink translocation</a:t>
              </a:r>
              <a:endPara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993311" y="2083055"/>
              <a:ext cx="12939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A cycle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" name="Straight Arrow Connector 27"/>
            <p:cNvCxnSpPr/>
            <p:nvPr/>
          </p:nvCxnSpPr>
          <p:spPr>
            <a:xfrm>
              <a:off x="3321170" y="817049"/>
              <a:ext cx="5746" cy="37740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/>
            <p:cNvCxnSpPr/>
            <p:nvPr/>
          </p:nvCxnSpPr>
          <p:spPr>
            <a:xfrm>
              <a:off x="5397260" y="833222"/>
              <a:ext cx="5746" cy="37740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Oval 30"/>
            <p:cNvSpPr/>
            <p:nvPr/>
          </p:nvSpPr>
          <p:spPr>
            <a:xfrm>
              <a:off x="2498827" y="2789596"/>
              <a:ext cx="3950219" cy="519619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yoxylate</a:t>
              </a:r>
              <a:r>
                <a:rPr lang="en-US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ycle &amp;Gluconeogenesis</a:t>
              </a:r>
              <a:endPara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5" name="Straight Arrow Connector 34"/>
            <p:cNvCxnSpPr/>
            <p:nvPr/>
          </p:nvCxnSpPr>
          <p:spPr>
            <a:xfrm>
              <a:off x="4451373" y="3357085"/>
              <a:ext cx="0" cy="2089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/>
            <p:cNvCxnSpPr/>
            <p:nvPr/>
          </p:nvCxnSpPr>
          <p:spPr>
            <a:xfrm>
              <a:off x="4488731" y="4623100"/>
              <a:ext cx="0" cy="2089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>
              <a:off x="4473936" y="5550881"/>
              <a:ext cx="0" cy="20891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2450403" y="821891"/>
              <a:ext cx="10006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oxidation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556183" y="809701"/>
              <a:ext cx="10006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olysis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49"/>
            <p:cNvSpPr/>
            <p:nvPr/>
          </p:nvSpPr>
          <p:spPr>
            <a:xfrm>
              <a:off x="2253726" y="454744"/>
              <a:ext cx="91940" cy="189782"/>
            </a:xfrm>
            <a:custGeom>
              <a:avLst/>
              <a:gdLst>
                <a:gd name="connsiteX0" fmla="*/ 22860 w 91940"/>
                <a:gd name="connsiteY0" fmla="*/ 1 h 189782"/>
                <a:gd name="connsiteX1" fmla="*/ 45719 w 91940"/>
                <a:gd name="connsiteY1" fmla="*/ 22861 h 189782"/>
                <a:gd name="connsiteX2" fmla="*/ 34289 w 91940"/>
                <a:gd name="connsiteY2" fmla="*/ 22861 h 189782"/>
                <a:gd name="connsiteX3" fmla="*/ 34289 w 91940"/>
                <a:gd name="connsiteY3" fmla="*/ 189782 h 189782"/>
                <a:gd name="connsiteX4" fmla="*/ 11430 w 91940"/>
                <a:gd name="connsiteY4" fmla="*/ 189782 h 189782"/>
                <a:gd name="connsiteX5" fmla="*/ 11430 w 91940"/>
                <a:gd name="connsiteY5" fmla="*/ 22861 h 189782"/>
                <a:gd name="connsiteX6" fmla="*/ 0 w 91940"/>
                <a:gd name="connsiteY6" fmla="*/ 22861 h 189782"/>
                <a:gd name="connsiteX7" fmla="*/ 69081 w 91940"/>
                <a:gd name="connsiteY7" fmla="*/ 0 h 189782"/>
                <a:gd name="connsiteX8" fmla="*/ 91940 w 91940"/>
                <a:gd name="connsiteY8" fmla="*/ 22860 h 189782"/>
                <a:gd name="connsiteX9" fmla="*/ 80510 w 91940"/>
                <a:gd name="connsiteY9" fmla="*/ 22860 h 189782"/>
                <a:gd name="connsiteX10" fmla="*/ 80510 w 91940"/>
                <a:gd name="connsiteY10" fmla="*/ 189781 h 189782"/>
                <a:gd name="connsiteX11" fmla="*/ 57651 w 91940"/>
                <a:gd name="connsiteY11" fmla="*/ 189781 h 189782"/>
                <a:gd name="connsiteX12" fmla="*/ 57651 w 91940"/>
                <a:gd name="connsiteY12" fmla="*/ 22860 h 189782"/>
                <a:gd name="connsiteX13" fmla="*/ 46221 w 91940"/>
                <a:gd name="connsiteY13" fmla="*/ 22860 h 1897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91940" h="189782">
                  <a:moveTo>
                    <a:pt x="22860" y="1"/>
                  </a:moveTo>
                  <a:lnTo>
                    <a:pt x="45719" y="22861"/>
                  </a:lnTo>
                  <a:lnTo>
                    <a:pt x="34289" y="22861"/>
                  </a:lnTo>
                  <a:lnTo>
                    <a:pt x="34289" y="189782"/>
                  </a:lnTo>
                  <a:lnTo>
                    <a:pt x="11430" y="189782"/>
                  </a:lnTo>
                  <a:lnTo>
                    <a:pt x="11430" y="22861"/>
                  </a:lnTo>
                  <a:lnTo>
                    <a:pt x="0" y="22861"/>
                  </a:lnTo>
                  <a:close/>
                  <a:moveTo>
                    <a:pt x="69081" y="0"/>
                  </a:moveTo>
                  <a:lnTo>
                    <a:pt x="91940" y="22860"/>
                  </a:lnTo>
                  <a:lnTo>
                    <a:pt x="80510" y="22860"/>
                  </a:lnTo>
                  <a:lnTo>
                    <a:pt x="80510" y="189781"/>
                  </a:lnTo>
                  <a:lnTo>
                    <a:pt x="57651" y="189781"/>
                  </a:lnTo>
                  <a:lnTo>
                    <a:pt x="57651" y="22860"/>
                  </a:lnTo>
                  <a:lnTo>
                    <a:pt x="46221" y="22860"/>
                  </a:lnTo>
                  <a:close/>
                </a:path>
              </a:pathLst>
            </a:cu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reeform 50"/>
            <p:cNvSpPr/>
            <p:nvPr/>
          </p:nvSpPr>
          <p:spPr>
            <a:xfrm>
              <a:off x="6417759" y="445704"/>
              <a:ext cx="91940" cy="189782"/>
            </a:xfrm>
            <a:custGeom>
              <a:avLst/>
              <a:gdLst>
                <a:gd name="connsiteX0" fmla="*/ 22860 w 91940"/>
                <a:gd name="connsiteY0" fmla="*/ 1 h 189782"/>
                <a:gd name="connsiteX1" fmla="*/ 45719 w 91940"/>
                <a:gd name="connsiteY1" fmla="*/ 22861 h 189782"/>
                <a:gd name="connsiteX2" fmla="*/ 34289 w 91940"/>
                <a:gd name="connsiteY2" fmla="*/ 22861 h 189782"/>
                <a:gd name="connsiteX3" fmla="*/ 34289 w 91940"/>
                <a:gd name="connsiteY3" fmla="*/ 189782 h 189782"/>
                <a:gd name="connsiteX4" fmla="*/ 11430 w 91940"/>
                <a:gd name="connsiteY4" fmla="*/ 189782 h 189782"/>
                <a:gd name="connsiteX5" fmla="*/ 11430 w 91940"/>
                <a:gd name="connsiteY5" fmla="*/ 22861 h 189782"/>
                <a:gd name="connsiteX6" fmla="*/ 0 w 91940"/>
                <a:gd name="connsiteY6" fmla="*/ 22861 h 189782"/>
                <a:gd name="connsiteX7" fmla="*/ 69081 w 91940"/>
                <a:gd name="connsiteY7" fmla="*/ 0 h 189782"/>
                <a:gd name="connsiteX8" fmla="*/ 91940 w 91940"/>
                <a:gd name="connsiteY8" fmla="*/ 22860 h 189782"/>
                <a:gd name="connsiteX9" fmla="*/ 80510 w 91940"/>
                <a:gd name="connsiteY9" fmla="*/ 22860 h 189782"/>
                <a:gd name="connsiteX10" fmla="*/ 80510 w 91940"/>
                <a:gd name="connsiteY10" fmla="*/ 189781 h 189782"/>
                <a:gd name="connsiteX11" fmla="*/ 57651 w 91940"/>
                <a:gd name="connsiteY11" fmla="*/ 189781 h 189782"/>
                <a:gd name="connsiteX12" fmla="*/ 57651 w 91940"/>
                <a:gd name="connsiteY12" fmla="*/ 22860 h 189782"/>
                <a:gd name="connsiteX13" fmla="*/ 46221 w 91940"/>
                <a:gd name="connsiteY13" fmla="*/ 22860 h 1897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91940" h="189782">
                  <a:moveTo>
                    <a:pt x="22860" y="1"/>
                  </a:moveTo>
                  <a:lnTo>
                    <a:pt x="45719" y="22861"/>
                  </a:lnTo>
                  <a:lnTo>
                    <a:pt x="34289" y="22861"/>
                  </a:lnTo>
                  <a:lnTo>
                    <a:pt x="34289" y="189782"/>
                  </a:lnTo>
                  <a:lnTo>
                    <a:pt x="11430" y="189782"/>
                  </a:lnTo>
                  <a:lnTo>
                    <a:pt x="11430" y="22861"/>
                  </a:lnTo>
                  <a:lnTo>
                    <a:pt x="0" y="22861"/>
                  </a:lnTo>
                  <a:close/>
                  <a:moveTo>
                    <a:pt x="69081" y="0"/>
                  </a:moveTo>
                  <a:lnTo>
                    <a:pt x="91940" y="22860"/>
                  </a:lnTo>
                  <a:lnTo>
                    <a:pt x="80510" y="22860"/>
                  </a:lnTo>
                  <a:lnTo>
                    <a:pt x="80510" y="189781"/>
                  </a:lnTo>
                  <a:lnTo>
                    <a:pt x="57651" y="189781"/>
                  </a:lnTo>
                  <a:lnTo>
                    <a:pt x="57651" y="22860"/>
                  </a:lnTo>
                  <a:lnTo>
                    <a:pt x="46221" y="22860"/>
                  </a:lnTo>
                  <a:close/>
                </a:path>
              </a:pathLst>
            </a:cu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Freeform 51"/>
            <p:cNvSpPr/>
            <p:nvPr/>
          </p:nvSpPr>
          <p:spPr>
            <a:xfrm>
              <a:off x="2358463" y="1688312"/>
              <a:ext cx="91940" cy="189782"/>
            </a:xfrm>
            <a:custGeom>
              <a:avLst/>
              <a:gdLst>
                <a:gd name="connsiteX0" fmla="*/ 22860 w 91940"/>
                <a:gd name="connsiteY0" fmla="*/ 1 h 189782"/>
                <a:gd name="connsiteX1" fmla="*/ 45719 w 91940"/>
                <a:gd name="connsiteY1" fmla="*/ 22861 h 189782"/>
                <a:gd name="connsiteX2" fmla="*/ 34289 w 91940"/>
                <a:gd name="connsiteY2" fmla="*/ 22861 h 189782"/>
                <a:gd name="connsiteX3" fmla="*/ 34289 w 91940"/>
                <a:gd name="connsiteY3" fmla="*/ 189782 h 189782"/>
                <a:gd name="connsiteX4" fmla="*/ 11430 w 91940"/>
                <a:gd name="connsiteY4" fmla="*/ 189782 h 189782"/>
                <a:gd name="connsiteX5" fmla="*/ 11430 w 91940"/>
                <a:gd name="connsiteY5" fmla="*/ 22861 h 189782"/>
                <a:gd name="connsiteX6" fmla="*/ 0 w 91940"/>
                <a:gd name="connsiteY6" fmla="*/ 22861 h 189782"/>
                <a:gd name="connsiteX7" fmla="*/ 69081 w 91940"/>
                <a:gd name="connsiteY7" fmla="*/ 0 h 189782"/>
                <a:gd name="connsiteX8" fmla="*/ 91940 w 91940"/>
                <a:gd name="connsiteY8" fmla="*/ 22860 h 189782"/>
                <a:gd name="connsiteX9" fmla="*/ 80510 w 91940"/>
                <a:gd name="connsiteY9" fmla="*/ 22860 h 189782"/>
                <a:gd name="connsiteX10" fmla="*/ 80510 w 91940"/>
                <a:gd name="connsiteY10" fmla="*/ 189781 h 189782"/>
                <a:gd name="connsiteX11" fmla="*/ 57651 w 91940"/>
                <a:gd name="connsiteY11" fmla="*/ 189781 h 189782"/>
                <a:gd name="connsiteX12" fmla="*/ 57651 w 91940"/>
                <a:gd name="connsiteY12" fmla="*/ 22860 h 189782"/>
                <a:gd name="connsiteX13" fmla="*/ 46221 w 91940"/>
                <a:gd name="connsiteY13" fmla="*/ 22860 h 1897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91940" h="189782">
                  <a:moveTo>
                    <a:pt x="22860" y="1"/>
                  </a:moveTo>
                  <a:lnTo>
                    <a:pt x="45719" y="22861"/>
                  </a:lnTo>
                  <a:lnTo>
                    <a:pt x="34289" y="22861"/>
                  </a:lnTo>
                  <a:lnTo>
                    <a:pt x="34289" y="189782"/>
                  </a:lnTo>
                  <a:lnTo>
                    <a:pt x="11430" y="189782"/>
                  </a:lnTo>
                  <a:lnTo>
                    <a:pt x="11430" y="22861"/>
                  </a:lnTo>
                  <a:lnTo>
                    <a:pt x="0" y="22861"/>
                  </a:lnTo>
                  <a:close/>
                  <a:moveTo>
                    <a:pt x="69081" y="0"/>
                  </a:moveTo>
                  <a:lnTo>
                    <a:pt x="91940" y="22860"/>
                  </a:lnTo>
                  <a:lnTo>
                    <a:pt x="80510" y="22860"/>
                  </a:lnTo>
                  <a:lnTo>
                    <a:pt x="80510" y="189781"/>
                  </a:lnTo>
                  <a:lnTo>
                    <a:pt x="57651" y="189781"/>
                  </a:lnTo>
                  <a:lnTo>
                    <a:pt x="57651" y="22860"/>
                  </a:lnTo>
                  <a:lnTo>
                    <a:pt x="46221" y="22860"/>
                  </a:lnTo>
                  <a:close/>
                </a:path>
              </a:pathLst>
            </a:cu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reeform 52"/>
            <p:cNvSpPr/>
            <p:nvPr/>
          </p:nvSpPr>
          <p:spPr>
            <a:xfrm>
              <a:off x="6400622" y="1698288"/>
              <a:ext cx="91940" cy="189782"/>
            </a:xfrm>
            <a:custGeom>
              <a:avLst/>
              <a:gdLst>
                <a:gd name="connsiteX0" fmla="*/ 22860 w 91940"/>
                <a:gd name="connsiteY0" fmla="*/ 1 h 189782"/>
                <a:gd name="connsiteX1" fmla="*/ 45719 w 91940"/>
                <a:gd name="connsiteY1" fmla="*/ 22861 h 189782"/>
                <a:gd name="connsiteX2" fmla="*/ 34289 w 91940"/>
                <a:gd name="connsiteY2" fmla="*/ 22861 h 189782"/>
                <a:gd name="connsiteX3" fmla="*/ 34289 w 91940"/>
                <a:gd name="connsiteY3" fmla="*/ 189782 h 189782"/>
                <a:gd name="connsiteX4" fmla="*/ 11430 w 91940"/>
                <a:gd name="connsiteY4" fmla="*/ 189782 h 189782"/>
                <a:gd name="connsiteX5" fmla="*/ 11430 w 91940"/>
                <a:gd name="connsiteY5" fmla="*/ 22861 h 189782"/>
                <a:gd name="connsiteX6" fmla="*/ 0 w 91940"/>
                <a:gd name="connsiteY6" fmla="*/ 22861 h 189782"/>
                <a:gd name="connsiteX7" fmla="*/ 69081 w 91940"/>
                <a:gd name="connsiteY7" fmla="*/ 0 h 189782"/>
                <a:gd name="connsiteX8" fmla="*/ 91940 w 91940"/>
                <a:gd name="connsiteY8" fmla="*/ 22860 h 189782"/>
                <a:gd name="connsiteX9" fmla="*/ 80510 w 91940"/>
                <a:gd name="connsiteY9" fmla="*/ 22860 h 189782"/>
                <a:gd name="connsiteX10" fmla="*/ 80510 w 91940"/>
                <a:gd name="connsiteY10" fmla="*/ 189781 h 189782"/>
                <a:gd name="connsiteX11" fmla="*/ 57651 w 91940"/>
                <a:gd name="connsiteY11" fmla="*/ 189781 h 189782"/>
                <a:gd name="connsiteX12" fmla="*/ 57651 w 91940"/>
                <a:gd name="connsiteY12" fmla="*/ 22860 h 189782"/>
                <a:gd name="connsiteX13" fmla="*/ 46221 w 91940"/>
                <a:gd name="connsiteY13" fmla="*/ 22860 h 1897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91940" h="189782">
                  <a:moveTo>
                    <a:pt x="22860" y="1"/>
                  </a:moveTo>
                  <a:lnTo>
                    <a:pt x="45719" y="22861"/>
                  </a:lnTo>
                  <a:lnTo>
                    <a:pt x="34289" y="22861"/>
                  </a:lnTo>
                  <a:lnTo>
                    <a:pt x="34289" y="189782"/>
                  </a:lnTo>
                  <a:lnTo>
                    <a:pt x="11430" y="189782"/>
                  </a:lnTo>
                  <a:lnTo>
                    <a:pt x="11430" y="22861"/>
                  </a:lnTo>
                  <a:lnTo>
                    <a:pt x="0" y="22861"/>
                  </a:lnTo>
                  <a:close/>
                  <a:moveTo>
                    <a:pt x="69081" y="0"/>
                  </a:moveTo>
                  <a:lnTo>
                    <a:pt x="91940" y="22860"/>
                  </a:lnTo>
                  <a:lnTo>
                    <a:pt x="80510" y="22860"/>
                  </a:lnTo>
                  <a:lnTo>
                    <a:pt x="80510" y="189781"/>
                  </a:lnTo>
                  <a:lnTo>
                    <a:pt x="57651" y="189781"/>
                  </a:lnTo>
                  <a:lnTo>
                    <a:pt x="57651" y="22860"/>
                  </a:lnTo>
                  <a:lnTo>
                    <a:pt x="46221" y="22860"/>
                  </a:lnTo>
                  <a:close/>
                </a:path>
              </a:pathLst>
            </a:cu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reeform 53"/>
            <p:cNvSpPr/>
            <p:nvPr/>
          </p:nvSpPr>
          <p:spPr>
            <a:xfrm>
              <a:off x="3345545" y="4249832"/>
              <a:ext cx="91940" cy="189782"/>
            </a:xfrm>
            <a:custGeom>
              <a:avLst/>
              <a:gdLst>
                <a:gd name="connsiteX0" fmla="*/ 22860 w 91940"/>
                <a:gd name="connsiteY0" fmla="*/ 1 h 189782"/>
                <a:gd name="connsiteX1" fmla="*/ 45719 w 91940"/>
                <a:gd name="connsiteY1" fmla="*/ 22861 h 189782"/>
                <a:gd name="connsiteX2" fmla="*/ 34289 w 91940"/>
                <a:gd name="connsiteY2" fmla="*/ 22861 h 189782"/>
                <a:gd name="connsiteX3" fmla="*/ 34289 w 91940"/>
                <a:gd name="connsiteY3" fmla="*/ 189782 h 189782"/>
                <a:gd name="connsiteX4" fmla="*/ 11430 w 91940"/>
                <a:gd name="connsiteY4" fmla="*/ 189782 h 189782"/>
                <a:gd name="connsiteX5" fmla="*/ 11430 w 91940"/>
                <a:gd name="connsiteY5" fmla="*/ 22861 h 189782"/>
                <a:gd name="connsiteX6" fmla="*/ 0 w 91940"/>
                <a:gd name="connsiteY6" fmla="*/ 22861 h 189782"/>
                <a:gd name="connsiteX7" fmla="*/ 69081 w 91940"/>
                <a:gd name="connsiteY7" fmla="*/ 0 h 189782"/>
                <a:gd name="connsiteX8" fmla="*/ 91940 w 91940"/>
                <a:gd name="connsiteY8" fmla="*/ 22860 h 189782"/>
                <a:gd name="connsiteX9" fmla="*/ 80510 w 91940"/>
                <a:gd name="connsiteY9" fmla="*/ 22860 h 189782"/>
                <a:gd name="connsiteX10" fmla="*/ 80510 w 91940"/>
                <a:gd name="connsiteY10" fmla="*/ 189781 h 189782"/>
                <a:gd name="connsiteX11" fmla="*/ 57651 w 91940"/>
                <a:gd name="connsiteY11" fmla="*/ 189781 h 189782"/>
                <a:gd name="connsiteX12" fmla="*/ 57651 w 91940"/>
                <a:gd name="connsiteY12" fmla="*/ 22860 h 189782"/>
                <a:gd name="connsiteX13" fmla="*/ 46221 w 91940"/>
                <a:gd name="connsiteY13" fmla="*/ 22860 h 1897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91940" h="189782">
                  <a:moveTo>
                    <a:pt x="22860" y="1"/>
                  </a:moveTo>
                  <a:lnTo>
                    <a:pt x="45719" y="22861"/>
                  </a:lnTo>
                  <a:lnTo>
                    <a:pt x="34289" y="22861"/>
                  </a:lnTo>
                  <a:lnTo>
                    <a:pt x="34289" y="189782"/>
                  </a:lnTo>
                  <a:lnTo>
                    <a:pt x="11430" y="189782"/>
                  </a:lnTo>
                  <a:lnTo>
                    <a:pt x="11430" y="22861"/>
                  </a:lnTo>
                  <a:lnTo>
                    <a:pt x="0" y="22861"/>
                  </a:lnTo>
                  <a:close/>
                  <a:moveTo>
                    <a:pt x="69081" y="0"/>
                  </a:moveTo>
                  <a:lnTo>
                    <a:pt x="91940" y="22860"/>
                  </a:lnTo>
                  <a:lnTo>
                    <a:pt x="80510" y="22860"/>
                  </a:lnTo>
                  <a:lnTo>
                    <a:pt x="80510" y="189781"/>
                  </a:lnTo>
                  <a:lnTo>
                    <a:pt x="57651" y="189781"/>
                  </a:lnTo>
                  <a:lnTo>
                    <a:pt x="57651" y="22860"/>
                  </a:lnTo>
                  <a:lnTo>
                    <a:pt x="46221" y="22860"/>
                  </a:lnTo>
                  <a:close/>
                </a:path>
              </a:pathLst>
            </a:cu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Freeform 54"/>
            <p:cNvSpPr/>
            <p:nvPr/>
          </p:nvSpPr>
          <p:spPr>
            <a:xfrm>
              <a:off x="319754" y="6455418"/>
              <a:ext cx="91940" cy="189782"/>
            </a:xfrm>
            <a:custGeom>
              <a:avLst/>
              <a:gdLst>
                <a:gd name="connsiteX0" fmla="*/ 22860 w 91940"/>
                <a:gd name="connsiteY0" fmla="*/ 1 h 189782"/>
                <a:gd name="connsiteX1" fmla="*/ 45719 w 91940"/>
                <a:gd name="connsiteY1" fmla="*/ 22861 h 189782"/>
                <a:gd name="connsiteX2" fmla="*/ 34289 w 91940"/>
                <a:gd name="connsiteY2" fmla="*/ 22861 h 189782"/>
                <a:gd name="connsiteX3" fmla="*/ 34289 w 91940"/>
                <a:gd name="connsiteY3" fmla="*/ 189782 h 189782"/>
                <a:gd name="connsiteX4" fmla="*/ 11430 w 91940"/>
                <a:gd name="connsiteY4" fmla="*/ 189782 h 189782"/>
                <a:gd name="connsiteX5" fmla="*/ 11430 w 91940"/>
                <a:gd name="connsiteY5" fmla="*/ 22861 h 189782"/>
                <a:gd name="connsiteX6" fmla="*/ 0 w 91940"/>
                <a:gd name="connsiteY6" fmla="*/ 22861 h 189782"/>
                <a:gd name="connsiteX7" fmla="*/ 69081 w 91940"/>
                <a:gd name="connsiteY7" fmla="*/ 0 h 189782"/>
                <a:gd name="connsiteX8" fmla="*/ 91940 w 91940"/>
                <a:gd name="connsiteY8" fmla="*/ 22860 h 189782"/>
                <a:gd name="connsiteX9" fmla="*/ 80510 w 91940"/>
                <a:gd name="connsiteY9" fmla="*/ 22860 h 189782"/>
                <a:gd name="connsiteX10" fmla="*/ 80510 w 91940"/>
                <a:gd name="connsiteY10" fmla="*/ 189781 h 189782"/>
                <a:gd name="connsiteX11" fmla="*/ 57651 w 91940"/>
                <a:gd name="connsiteY11" fmla="*/ 189781 h 189782"/>
                <a:gd name="connsiteX12" fmla="*/ 57651 w 91940"/>
                <a:gd name="connsiteY12" fmla="*/ 22860 h 189782"/>
                <a:gd name="connsiteX13" fmla="*/ 46221 w 91940"/>
                <a:gd name="connsiteY13" fmla="*/ 22860 h 1897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91940" h="189782">
                  <a:moveTo>
                    <a:pt x="22860" y="1"/>
                  </a:moveTo>
                  <a:lnTo>
                    <a:pt x="45719" y="22861"/>
                  </a:lnTo>
                  <a:lnTo>
                    <a:pt x="34289" y="22861"/>
                  </a:lnTo>
                  <a:lnTo>
                    <a:pt x="34289" y="189782"/>
                  </a:lnTo>
                  <a:lnTo>
                    <a:pt x="11430" y="189782"/>
                  </a:lnTo>
                  <a:lnTo>
                    <a:pt x="11430" y="22861"/>
                  </a:lnTo>
                  <a:lnTo>
                    <a:pt x="0" y="22861"/>
                  </a:lnTo>
                  <a:close/>
                  <a:moveTo>
                    <a:pt x="69081" y="0"/>
                  </a:moveTo>
                  <a:lnTo>
                    <a:pt x="91940" y="22860"/>
                  </a:lnTo>
                  <a:lnTo>
                    <a:pt x="80510" y="22860"/>
                  </a:lnTo>
                  <a:lnTo>
                    <a:pt x="80510" y="189781"/>
                  </a:lnTo>
                  <a:lnTo>
                    <a:pt x="57651" y="189781"/>
                  </a:lnTo>
                  <a:lnTo>
                    <a:pt x="57651" y="22860"/>
                  </a:lnTo>
                  <a:lnTo>
                    <a:pt x="46221" y="22860"/>
                  </a:lnTo>
                  <a:close/>
                </a:path>
              </a:pathLst>
            </a:cu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" name="Straight Arrow Connector 2"/>
            <p:cNvCxnSpPr/>
            <p:nvPr/>
          </p:nvCxnSpPr>
          <p:spPr>
            <a:xfrm flipH="1">
              <a:off x="4445330" y="2481532"/>
              <a:ext cx="2726" cy="308064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Rounded Rectangle 26"/>
            <p:cNvSpPr/>
            <p:nvPr/>
          </p:nvSpPr>
          <p:spPr>
            <a:xfrm>
              <a:off x="3451067" y="3562805"/>
              <a:ext cx="2142227" cy="336430"/>
            </a:xfrm>
            <a:prstGeom prst="roundRect">
              <a:avLst/>
            </a:prstGeom>
            <a:solidFill>
              <a:schemeClr val="accent2"/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creased Hexose content</a:t>
              </a:r>
              <a:endPara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ounded Rectangle 31"/>
            <p:cNvSpPr/>
            <p:nvPr/>
          </p:nvSpPr>
          <p:spPr>
            <a:xfrm>
              <a:off x="6239436" y="3453449"/>
              <a:ext cx="2861533" cy="506089"/>
            </a:xfrm>
            <a:prstGeom prst="roundRect">
              <a:avLst/>
            </a:prstGeom>
            <a:solidFill>
              <a:srgbClr val="FFC000"/>
            </a:solidFill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gnal for early floral development, and early senescence</a:t>
              </a:r>
              <a:endPara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8" name="Straight Arrow Connector 37"/>
            <p:cNvCxnSpPr/>
            <p:nvPr/>
          </p:nvCxnSpPr>
          <p:spPr>
            <a:xfrm>
              <a:off x="5662410" y="3706493"/>
              <a:ext cx="577026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 flipH="1">
              <a:off x="4476257" y="3899235"/>
              <a:ext cx="1" cy="285423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652922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70994" y="271022"/>
            <a:ext cx="8427022" cy="4922079"/>
            <a:chOff x="1570994" y="271022"/>
            <a:chExt cx="8427022" cy="492207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7162"/>
            <a:stretch/>
          </p:blipFill>
          <p:spPr>
            <a:xfrm>
              <a:off x="1570994" y="271022"/>
              <a:ext cx="8427022" cy="4283725"/>
            </a:xfrm>
            <a:prstGeom prst="rect">
              <a:avLst/>
            </a:prstGeom>
          </p:spPr>
        </p:pic>
        <p:grpSp>
          <p:nvGrpSpPr>
            <p:cNvPr id="5" name="Group 4"/>
            <p:cNvGrpSpPr/>
            <p:nvPr/>
          </p:nvGrpSpPr>
          <p:grpSpPr>
            <a:xfrm>
              <a:off x="5900468" y="1699404"/>
              <a:ext cx="539644" cy="266752"/>
              <a:chOff x="1285336" y="5451893"/>
              <a:chExt cx="836762" cy="457201"/>
            </a:xfrm>
          </p:grpSpPr>
          <p:sp>
            <p:nvSpPr>
              <p:cNvPr id="6" name="Oval 5"/>
              <p:cNvSpPr/>
              <p:nvPr/>
            </p:nvSpPr>
            <p:spPr>
              <a:xfrm>
                <a:off x="1285336" y="545189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" name="Straight Arrow Connector 6"/>
              <p:cNvCxnSpPr/>
              <p:nvPr/>
            </p:nvCxnSpPr>
            <p:spPr>
              <a:xfrm flipV="1">
                <a:off x="1634705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Arrow Connector 7"/>
              <p:cNvCxnSpPr/>
              <p:nvPr/>
            </p:nvCxnSpPr>
            <p:spPr>
              <a:xfrm flipV="1">
                <a:off x="1777754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oup 8"/>
            <p:cNvGrpSpPr/>
            <p:nvPr/>
          </p:nvGrpSpPr>
          <p:grpSpPr>
            <a:xfrm>
              <a:off x="8655157" y="1558734"/>
              <a:ext cx="540601" cy="349173"/>
              <a:chOff x="1285336" y="5451893"/>
              <a:chExt cx="836762" cy="457201"/>
            </a:xfrm>
          </p:grpSpPr>
          <p:sp>
            <p:nvSpPr>
              <p:cNvPr id="10" name="Oval 9"/>
              <p:cNvSpPr/>
              <p:nvPr/>
            </p:nvSpPr>
            <p:spPr>
              <a:xfrm>
                <a:off x="1285336" y="545189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1" name="Straight Arrow Connector 10"/>
              <p:cNvCxnSpPr/>
              <p:nvPr/>
            </p:nvCxnSpPr>
            <p:spPr>
              <a:xfrm flipV="1">
                <a:off x="1634705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Arrow Connector 11"/>
              <p:cNvCxnSpPr/>
              <p:nvPr/>
            </p:nvCxnSpPr>
            <p:spPr>
              <a:xfrm flipV="1">
                <a:off x="1777754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oup 12"/>
            <p:cNvGrpSpPr/>
            <p:nvPr/>
          </p:nvGrpSpPr>
          <p:grpSpPr>
            <a:xfrm>
              <a:off x="3176453" y="3052019"/>
              <a:ext cx="299993" cy="226019"/>
              <a:chOff x="1285336" y="5451893"/>
              <a:chExt cx="836762" cy="457201"/>
            </a:xfrm>
          </p:grpSpPr>
          <p:sp>
            <p:nvSpPr>
              <p:cNvPr id="14" name="Oval 13"/>
              <p:cNvSpPr/>
              <p:nvPr/>
            </p:nvSpPr>
            <p:spPr>
              <a:xfrm>
                <a:off x="1285336" y="545189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V="1">
                <a:off x="1634705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Arrow Connector 15"/>
              <p:cNvCxnSpPr/>
              <p:nvPr/>
            </p:nvCxnSpPr>
            <p:spPr>
              <a:xfrm flipV="1">
                <a:off x="1777754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Group 16"/>
            <p:cNvGrpSpPr/>
            <p:nvPr/>
          </p:nvGrpSpPr>
          <p:grpSpPr>
            <a:xfrm>
              <a:off x="2064404" y="4843928"/>
              <a:ext cx="540601" cy="349173"/>
              <a:chOff x="1285336" y="5451893"/>
              <a:chExt cx="836762" cy="457201"/>
            </a:xfrm>
          </p:grpSpPr>
          <p:sp>
            <p:nvSpPr>
              <p:cNvPr id="18" name="Oval 17"/>
              <p:cNvSpPr/>
              <p:nvPr/>
            </p:nvSpPr>
            <p:spPr>
              <a:xfrm>
                <a:off x="1285336" y="545189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9" name="Straight Arrow Connector 18"/>
              <p:cNvCxnSpPr/>
              <p:nvPr/>
            </p:nvCxnSpPr>
            <p:spPr>
              <a:xfrm flipV="1">
                <a:off x="1634705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Arrow Connector 19"/>
              <p:cNvCxnSpPr/>
              <p:nvPr/>
            </p:nvCxnSpPr>
            <p:spPr>
              <a:xfrm flipV="1">
                <a:off x="1777754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" name="TextBox 20"/>
            <p:cNvSpPr txBox="1"/>
            <p:nvPr/>
          </p:nvSpPr>
          <p:spPr>
            <a:xfrm>
              <a:off x="2605005" y="4880014"/>
              <a:ext cx="10380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/>
                <a:t>Upregulation</a:t>
              </a:r>
              <a:endParaRPr 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201496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767638" y="155385"/>
            <a:ext cx="8765879" cy="5884162"/>
            <a:chOff x="2767638" y="155385"/>
            <a:chExt cx="8765879" cy="5884162"/>
          </a:xfrm>
        </p:grpSpPr>
        <p:sp>
          <p:nvSpPr>
            <p:cNvPr id="4" name="Rounded Rectangle 3"/>
            <p:cNvSpPr/>
            <p:nvPr/>
          </p:nvSpPr>
          <p:spPr>
            <a:xfrm>
              <a:off x="2767638" y="2178894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Sedoheptulose-7-phosphate</a:t>
              </a:r>
              <a:endParaRPr lang="en-US" sz="900" dirty="0"/>
            </a:p>
          </p:txBody>
        </p:sp>
        <p:sp>
          <p:nvSpPr>
            <p:cNvPr id="5" name="Rounded Rectangle 4"/>
            <p:cNvSpPr/>
            <p:nvPr/>
          </p:nvSpPr>
          <p:spPr>
            <a:xfrm>
              <a:off x="2767638" y="3381186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Sedoheptulose-1,7-bisphosphate</a:t>
              </a:r>
              <a:endParaRPr lang="en-US" sz="900" dirty="0"/>
            </a:p>
          </p:txBody>
        </p:sp>
        <p:sp>
          <p:nvSpPr>
            <p:cNvPr id="6" name="Rounded Rectangle 5"/>
            <p:cNvSpPr/>
            <p:nvPr/>
          </p:nvSpPr>
          <p:spPr>
            <a:xfrm>
              <a:off x="2767638" y="4790927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Erythrose-4-phosphate</a:t>
              </a:r>
              <a:endParaRPr lang="en-US" sz="900" dirty="0"/>
            </a:p>
          </p:txBody>
        </p:sp>
        <p:sp>
          <p:nvSpPr>
            <p:cNvPr id="7" name="Rounded Rectangle 6"/>
            <p:cNvSpPr/>
            <p:nvPr/>
          </p:nvSpPr>
          <p:spPr>
            <a:xfrm>
              <a:off x="5168648" y="4790927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Fructose-6-phosphate</a:t>
              </a:r>
              <a:endParaRPr lang="en-US" sz="900" dirty="0"/>
            </a:p>
          </p:txBody>
        </p:sp>
        <p:sp>
          <p:nvSpPr>
            <p:cNvPr id="8" name="Rounded Rectangle 7"/>
            <p:cNvSpPr/>
            <p:nvPr/>
          </p:nvSpPr>
          <p:spPr>
            <a:xfrm>
              <a:off x="4569113" y="2171192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Xylulose-5-phosphate</a:t>
              </a:r>
              <a:endParaRPr lang="en-US" sz="900" dirty="0"/>
            </a:p>
          </p:txBody>
        </p:sp>
        <p:sp>
          <p:nvSpPr>
            <p:cNvPr id="9" name="Rounded Rectangle 8"/>
            <p:cNvSpPr/>
            <p:nvPr/>
          </p:nvSpPr>
          <p:spPr>
            <a:xfrm>
              <a:off x="6991709" y="4790927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Fructose-1,6-bisphosphate</a:t>
              </a:r>
              <a:endParaRPr lang="en-US" sz="900" dirty="0"/>
            </a:p>
          </p:txBody>
        </p:sp>
        <p:sp>
          <p:nvSpPr>
            <p:cNvPr id="10" name="Rounded Rectangle 9"/>
            <p:cNvSpPr/>
            <p:nvPr/>
          </p:nvSpPr>
          <p:spPr>
            <a:xfrm>
              <a:off x="9038322" y="4772924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err="1" smtClean="0"/>
                <a:t>Dihydroxyacetone</a:t>
              </a:r>
              <a:r>
                <a:rPr lang="en-US" sz="900" dirty="0" smtClean="0"/>
                <a:t> phosphate (DAHP)</a:t>
              </a:r>
              <a:endParaRPr lang="en-US" sz="900" dirty="0"/>
            </a:p>
          </p:txBody>
        </p:sp>
        <p:sp>
          <p:nvSpPr>
            <p:cNvPr id="11" name="Rounded Rectangle 10"/>
            <p:cNvSpPr/>
            <p:nvPr/>
          </p:nvSpPr>
          <p:spPr>
            <a:xfrm>
              <a:off x="9038322" y="3146661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Glyceraldehyde-3-phosphate (G3P)</a:t>
              </a:r>
              <a:endParaRPr lang="en-US" sz="900" dirty="0"/>
            </a:p>
          </p:txBody>
        </p:sp>
        <p:sp>
          <p:nvSpPr>
            <p:cNvPr id="12" name="Rounded Rectangle 11"/>
            <p:cNvSpPr/>
            <p:nvPr/>
          </p:nvSpPr>
          <p:spPr>
            <a:xfrm>
              <a:off x="9038322" y="1929288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1,3-Bisphosphoglycerate</a:t>
              </a:r>
              <a:endParaRPr lang="en-US" sz="900" dirty="0"/>
            </a:p>
          </p:txBody>
        </p:sp>
        <p:sp>
          <p:nvSpPr>
            <p:cNvPr id="13" name="Rounded Rectangle 12"/>
            <p:cNvSpPr/>
            <p:nvPr/>
          </p:nvSpPr>
          <p:spPr>
            <a:xfrm>
              <a:off x="9038322" y="564193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3-Phosphoglycerate (3-PGA)</a:t>
              </a:r>
              <a:endParaRPr lang="en-US" sz="900" dirty="0"/>
            </a:p>
          </p:txBody>
        </p:sp>
        <p:sp>
          <p:nvSpPr>
            <p:cNvPr id="14" name="Rounded Rectangle 13"/>
            <p:cNvSpPr/>
            <p:nvPr/>
          </p:nvSpPr>
          <p:spPr>
            <a:xfrm>
              <a:off x="5664313" y="552106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Ribulose-1,5-bisphosphate</a:t>
              </a:r>
              <a:endParaRPr lang="en-US" sz="900" dirty="0"/>
            </a:p>
          </p:txBody>
        </p:sp>
        <p:sp>
          <p:nvSpPr>
            <p:cNvPr id="15" name="Rounded Rectangle 14"/>
            <p:cNvSpPr/>
            <p:nvPr/>
          </p:nvSpPr>
          <p:spPr>
            <a:xfrm>
              <a:off x="2769783" y="562455"/>
              <a:ext cx="1199071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Ribulose-5-phosphate</a:t>
              </a:r>
              <a:endParaRPr lang="en-US" sz="900" dirty="0"/>
            </a:p>
          </p:txBody>
        </p:sp>
        <p:sp>
          <p:nvSpPr>
            <p:cNvPr id="16" name="Rounded Rectangle 15"/>
            <p:cNvSpPr/>
            <p:nvPr/>
          </p:nvSpPr>
          <p:spPr>
            <a:xfrm>
              <a:off x="7440285" y="881647"/>
              <a:ext cx="1199071" cy="293298"/>
            </a:xfrm>
            <a:prstGeom prst="roundRect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/>
                <a:t>RUBISCO</a:t>
              </a:r>
              <a:endParaRPr lang="en-US" sz="900" dirty="0"/>
            </a:p>
          </p:txBody>
        </p:sp>
        <p:cxnSp>
          <p:nvCxnSpPr>
            <p:cNvPr id="25" name="Straight Arrow Connector 24"/>
            <p:cNvCxnSpPr/>
            <p:nvPr/>
          </p:nvCxnSpPr>
          <p:spPr>
            <a:xfrm flipV="1">
              <a:off x="3347049" y="957532"/>
              <a:ext cx="20124" cy="108369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>
              <a:off x="4267911" y="684391"/>
              <a:ext cx="1242204" cy="575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/>
            <p:nvPr/>
          </p:nvCxnSpPr>
          <p:spPr>
            <a:xfrm>
              <a:off x="4027086" y="2317841"/>
              <a:ext cx="481650" cy="770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/>
            <p:cNvCxnSpPr/>
            <p:nvPr/>
          </p:nvCxnSpPr>
          <p:spPr>
            <a:xfrm flipV="1">
              <a:off x="3367173" y="2562045"/>
              <a:ext cx="0" cy="74188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/>
            <p:cNvCxnSpPr/>
            <p:nvPr/>
          </p:nvCxnSpPr>
          <p:spPr>
            <a:xfrm flipH="1" flipV="1">
              <a:off x="3966709" y="889459"/>
              <a:ext cx="1054935" cy="126358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 flipH="1" flipV="1">
              <a:off x="3370044" y="3751740"/>
              <a:ext cx="1" cy="102118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/>
            <p:cNvCxnSpPr/>
            <p:nvPr/>
          </p:nvCxnSpPr>
          <p:spPr>
            <a:xfrm flipH="1">
              <a:off x="4041815" y="4937576"/>
              <a:ext cx="105493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 flipH="1">
              <a:off x="6385352" y="4937576"/>
              <a:ext cx="55028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 flipH="1">
              <a:off x="8208028" y="4937576"/>
              <a:ext cx="72461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>
              <a:off x="9637857" y="3545971"/>
              <a:ext cx="0" cy="116493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/>
            <p:cNvCxnSpPr/>
            <p:nvPr/>
          </p:nvCxnSpPr>
          <p:spPr>
            <a:xfrm>
              <a:off x="9637857" y="2367626"/>
              <a:ext cx="0" cy="77637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>
              <a:off x="9622755" y="1034661"/>
              <a:ext cx="15102" cy="73018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>
              <a:off x="6935638" y="684391"/>
              <a:ext cx="1997006" cy="1436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Rounded Rectangle 52"/>
            <p:cNvSpPr/>
            <p:nvPr/>
          </p:nvSpPr>
          <p:spPr>
            <a:xfrm>
              <a:off x="7992373" y="155385"/>
              <a:ext cx="819509" cy="284315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 smtClean="0"/>
                <a:t>INPUT: 3CO2+H2O</a:t>
              </a:r>
              <a:endParaRPr lang="en-US" sz="900" b="1" dirty="0"/>
            </a:p>
          </p:txBody>
        </p:sp>
        <p:sp>
          <p:nvSpPr>
            <p:cNvPr id="60" name="Bent Arrow 59"/>
            <p:cNvSpPr/>
            <p:nvPr/>
          </p:nvSpPr>
          <p:spPr>
            <a:xfrm>
              <a:off x="8003148" y="644767"/>
              <a:ext cx="142339" cy="179827"/>
            </a:xfrm>
            <a:prstGeom prst="bent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2" name="Bent Arrow 61"/>
            <p:cNvSpPr/>
            <p:nvPr/>
          </p:nvSpPr>
          <p:spPr>
            <a:xfrm flipV="1">
              <a:off x="8208028" y="527965"/>
              <a:ext cx="189781" cy="194850"/>
            </a:xfrm>
            <a:prstGeom prst="bentArrow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3" name="Rounded Rectangle 62"/>
            <p:cNvSpPr/>
            <p:nvPr/>
          </p:nvSpPr>
          <p:spPr>
            <a:xfrm>
              <a:off x="10541478" y="3157281"/>
              <a:ext cx="992039" cy="293298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b="1" dirty="0" smtClean="0"/>
                <a:t>OUTPUT: (a G3P molecule)</a:t>
              </a:r>
              <a:endParaRPr lang="en-US" sz="900" b="1" dirty="0"/>
            </a:p>
          </p:txBody>
        </p:sp>
        <p:cxnSp>
          <p:nvCxnSpPr>
            <p:cNvPr id="65" name="Straight Arrow Connector 64"/>
            <p:cNvCxnSpPr>
              <a:endCxn id="63" idx="1"/>
            </p:cNvCxnSpPr>
            <p:nvPr/>
          </p:nvCxnSpPr>
          <p:spPr>
            <a:xfrm>
              <a:off x="10325819" y="3303930"/>
              <a:ext cx="21565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2" name="Group 71"/>
            <p:cNvGrpSpPr/>
            <p:nvPr/>
          </p:nvGrpSpPr>
          <p:grpSpPr>
            <a:xfrm>
              <a:off x="2767638" y="5582346"/>
              <a:ext cx="836762" cy="457201"/>
              <a:chOff x="1285336" y="5451893"/>
              <a:chExt cx="836762" cy="457201"/>
            </a:xfrm>
          </p:grpSpPr>
          <p:sp>
            <p:nvSpPr>
              <p:cNvPr id="66" name="Oval 65"/>
              <p:cNvSpPr/>
              <p:nvPr/>
            </p:nvSpPr>
            <p:spPr>
              <a:xfrm>
                <a:off x="1285336" y="545189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8" name="Straight Arrow Connector 67"/>
              <p:cNvCxnSpPr/>
              <p:nvPr/>
            </p:nvCxnSpPr>
            <p:spPr>
              <a:xfrm flipV="1">
                <a:off x="1634705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/>
              <p:cNvCxnSpPr/>
              <p:nvPr/>
            </p:nvCxnSpPr>
            <p:spPr>
              <a:xfrm flipV="1">
                <a:off x="1777754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Group 72"/>
            <p:cNvGrpSpPr/>
            <p:nvPr/>
          </p:nvGrpSpPr>
          <p:grpSpPr>
            <a:xfrm>
              <a:off x="8184312" y="4375420"/>
              <a:ext cx="836762" cy="457201"/>
              <a:chOff x="1285336" y="5451893"/>
              <a:chExt cx="836762" cy="457201"/>
            </a:xfrm>
          </p:grpSpPr>
          <p:sp>
            <p:nvSpPr>
              <p:cNvPr id="74" name="Oval 73"/>
              <p:cNvSpPr/>
              <p:nvPr/>
            </p:nvSpPr>
            <p:spPr>
              <a:xfrm>
                <a:off x="1285336" y="545189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5" name="Straight Arrow Connector 74"/>
              <p:cNvCxnSpPr/>
              <p:nvPr/>
            </p:nvCxnSpPr>
            <p:spPr>
              <a:xfrm flipV="1">
                <a:off x="1634705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Arrow Connector 75"/>
              <p:cNvCxnSpPr/>
              <p:nvPr/>
            </p:nvCxnSpPr>
            <p:spPr>
              <a:xfrm flipV="1">
                <a:off x="1777754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 76"/>
            <p:cNvGrpSpPr/>
            <p:nvPr/>
          </p:nvGrpSpPr>
          <p:grpSpPr>
            <a:xfrm>
              <a:off x="4180923" y="4372352"/>
              <a:ext cx="836762" cy="457201"/>
              <a:chOff x="1285336" y="5451893"/>
              <a:chExt cx="836762" cy="457201"/>
            </a:xfrm>
          </p:grpSpPr>
          <p:sp>
            <p:nvSpPr>
              <p:cNvPr id="78" name="Oval 77"/>
              <p:cNvSpPr/>
              <p:nvPr/>
            </p:nvSpPr>
            <p:spPr>
              <a:xfrm>
                <a:off x="1285336" y="545189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9" name="Straight Arrow Connector 78"/>
              <p:cNvCxnSpPr/>
              <p:nvPr/>
            </p:nvCxnSpPr>
            <p:spPr>
              <a:xfrm flipV="1">
                <a:off x="1634705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Arrow Connector 79"/>
              <p:cNvCxnSpPr/>
              <p:nvPr/>
            </p:nvCxnSpPr>
            <p:spPr>
              <a:xfrm flipV="1">
                <a:off x="1777754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 80"/>
            <p:cNvGrpSpPr/>
            <p:nvPr/>
          </p:nvGrpSpPr>
          <p:grpSpPr>
            <a:xfrm>
              <a:off x="3431149" y="2686772"/>
              <a:ext cx="836762" cy="457201"/>
              <a:chOff x="1285336" y="5451893"/>
              <a:chExt cx="836762" cy="457201"/>
            </a:xfrm>
          </p:grpSpPr>
          <p:sp>
            <p:nvSpPr>
              <p:cNvPr id="82" name="Oval 81"/>
              <p:cNvSpPr/>
              <p:nvPr/>
            </p:nvSpPr>
            <p:spPr>
              <a:xfrm>
                <a:off x="1285336" y="545189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83" name="Straight Arrow Connector 82"/>
              <p:cNvCxnSpPr/>
              <p:nvPr/>
            </p:nvCxnSpPr>
            <p:spPr>
              <a:xfrm flipV="1">
                <a:off x="1634705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Arrow Connector 83"/>
              <p:cNvCxnSpPr/>
              <p:nvPr/>
            </p:nvCxnSpPr>
            <p:spPr>
              <a:xfrm flipV="1">
                <a:off x="1777754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Group 84"/>
            <p:cNvGrpSpPr/>
            <p:nvPr/>
          </p:nvGrpSpPr>
          <p:grpSpPr>
            <a:xfrm>
              <a:off x="3871809" y="1758483"/>
              <a:ext cx="836762" cy="457201"/>
              <a:chOff x="1285336" y="5451893"/>
              <a:chExt cx="836762" cy="457201"/>
            </a:xfrm>
          </p:grpSpPr>
          <p:sp>
            <p:nvSpPr>
              <p:cNvPr id="86" name="Oval 85"/>
              <p:cNvSpPr/>
              <p:nvPr/>
            </p:nvSpPr>
            <p:spPr>
              <a:xfrm>
                <a:off x="1285336" y="545189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87" name="Straight Arrow Connector 86"/>
              <p:cNvCxnSpPr/>
              <p:nvPr/>
            </p:nvCxnSpPr>
            <p:spPr>
              <a:xfrm flipV="1">
                <a:off x="1634705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Arrow Connector 87"/>
              <p:cNvCxnSpPr/>
              <p:nvPr/>
            </p:nvCxnSpPr>
            <p:spPr>
              <a:xfrm flipV="1">
                <a:off x="1777754" y="551002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9" name="Oval 88"/>
            <p:cNvSpPr/>
            <p:nvPr/>
          </p:nvSpPr>
          <p:spPr>
            <a:xfrm>
              <a:off x="4163669" y="2367626"/>
              <a:ext cx="254479" cy="267418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 smtClean="0"/>
                <a:t>2</a:t>
              </a:r>
              <a:endParaRPr lang="en-US" b="1" dirty="0"/>
            </a:p>
          </p:txBody>
        </p:sp>
        <p:sp>
          <p:nvSpPr>
            <p:cNvPr id="90" name="Oval 89"/>
            <p:cNvSpPr/>
            <p:nvPr/>
          </p:nvSpPr>
          <p:spPr>
            <a:xfrm>
              <a:off x="3041170" y="2785237"/>
              <a:ext cx="254479" cy="267418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 smtClean="0"/>
                <a:t>3</a:t>
              </a:r>
              <a:endParaRPr lang="en-US" b="1" dirty="0"/>
            </a:p>
          </p:txBody>
        </p:sp>
        <p:sp>
          <p:nvSpPr>
            <p:cNvPr id="91" name="Oval 90"/>
            <p:cNvSpPr/>
            <p:nvPr/>
          </p:nvSpPr>
          <p:spPr>
            <a:xfrm>
              <a:off x="4472064" y="5018483"/>
              <a:ext cx="254479" cy="267418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 smtClean="0"/>
                <a:t>2</a:t>
              </a:r>
              <a:endParaRPr lang="en-US" b="1" dirty="0"/>
            </a:p>
          </p:txBody>
        </p:sp>
        <p:sp>
          <p:nvSpPr>
            <p:cNvPr id="92" name="Oval 91"/>
            <p:cNvSpPr/>
            <p:nvPr/>
          </p:nvSpPr>
          <p:spPr>
            <a:xfrm>
              <a:off x="8475454" y="4967770"/>
              <a:ext cx="254479" cy="267418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 smtClean="0"/>
                <a:t>1</a:t>
              </a:r>
              <a:endParaRPr lang="en-US" b="1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3604400" y="5657059"/>
              <a:ext cx="140970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Overexpression</a:t>
              </a:r>
              <a:endParaRPr 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6073614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953" y="70203"/>
            <a:ext cx="10515600" cy="4030281"/>
          </a:xfrm>
        </p:spPr>
      </p:pic>
      <p:sp>
        <p:nvSpPr>
          <p:cNvPr id="6" name="Rectangle 5"/>
          <p:cNvSpPr/>
          <p:nvPr/>
        </p:nvSpPr>
        <p:spPr>
          <a:xfrm>
            <a:off x="2354214" y="4899577"/>
            <a:ext cx="1962076" cy="37956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err="1" smtClean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upregulation</a:t>
            </a:r>
            <a:endParaRPr lang="en-US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22" name="Explosion 1 21"/>
          <p:cNvSpPr/>
          <p:nvPr/>
        </p:nvSpPr>
        <p:spPr>
          <a:xfrm>
            <a:off x="5371660" y="3966694"/>
            <a:ext cx="2410691" cy="1765396"/>
          </a:xfrm>
          <a:prstGeom prst="irregularSeal1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200" b="1" dirty="0" smtClean="0"/>
              <a:t>ROS</a:t>
            </a:r>
            <a:endParaRPr lang="en-US" sz="3200" b="1" dirty="0"/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5248894" y="3363878"/>
            <a:ext cx="605641" cy="828112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7168060" y="3363878"/>
            <a:ext cx="510639" cy="736606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0" name="Group 9"/>
          <p:cNvGrpSpPr/>
          <p:nvPr/>
        </p:nvGrpSpPr>
        <p:grpSpPr>
          <a:xfrm>
            <a:off x="1517452" y="381572"/>
            <a:ext cx="7101661" cy="4936386"/>
            <a:chOff x="1517452" y="381572"/>
            <a:chExt cx="7101661" cy="4936386"/>
          </a:xfrm>
        </p:grpSpPr>
        <p:grpSp>
          <p:nvGrpSpPr>
            <p:cNvPr id="7" name="Group 6"/>
            <p:cNvGrpSpPr/>
            <p:nvPr/>
          </p:nvGrpSpPr>
          <p:grpSpPr>
            <a:xfrm>
              <a:off x="1517452" y="4860757"/>
              <a:ext cx="836762" cy="457201"/>
              <a:chOff x="1517452" y="4860757"/>
              <a:chExt cx="836762" cy="457201"/>
            </a:xfrm>
          </p:grpSpPr>
          <p:sp>
            <p:nvSpPr>
              <p:cNvPr id="23" name="Oval 22"/>
              <p:cNvSpPr/>
              <p:nvPr/>
            </p:nvSpPr>
            <p:spPr>
              <a:xfrm>
                <a:off x="1517452" y="4860757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6" name="Straight Arrow Connector 25"/>
              <p:cNvCxnSpPr/>
              <p:nvPr/>
            </p:nvCxnSpPr>
            <p:spPr>
              <a:xfrm flipV="1">
                <a:off x="1866821" y="4918889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/>
              <p:cNvCxnSpPr/>
              <p:nvPr/>
            </p:nvCxnSpPr>
            <p:spPr>
              <a:xfrm flipV="1">
                <a:off x="2009870" y="4918889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" name="Group 7"/>
            <p:cNvGrpSpPr/>
            <p:nvPr/>
          </p:nvGrpSpPr>
          <p:grpSpPr>
            <a:xfrm>
              <a:off x="4151036" y="381573"/>
              <a:ext cx="836762" cy="457201"/>
              <a:chOff x="4151036" y="381573"/>
              <a:chExt cx="836762" cy="457201"/>
            </a:xfrm>
          </p:grpSpPr>
          <p:sp>
            <p:nvSpPr>
              <p:cNvPr id="29" name="Oval 28"/>
              <p:cNvSpPr/>
              <p:nvPr/>
            </p:nvSpPr>
            <p:spPr>
              <a:xfrm>
                <a:off x="4151036" y="381573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0" name="Straight Arrow Connector 29"/>
              <p:cNvCxnSpPr/>
              <p:nvPr/>
            </p:nvCxnSpPr>
            <p:spPr>
              <a:xfrm flipV="1">
                <a:off x="4500405" y="43970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/>
              <p:cNvCxnSpPr/>
              <p:nvPr/>
            </p:nvCxnSpPr>
            <p:spPr>
              <a:xfrm flipV="1">
                <a:off x="4643454" y="439705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oup 8"/>
            <p:cNvGrpSpPr/>
            <p:nvPr/>
          </p:nvGrpSpPr>
          <p:grpSpPr>
            <a:xfrm>
              <a:off x="7782351" y="381572"/>
              <a:ext cx="836762" cy="457201"/>
              <a:chOff x="7782351" y="381572"/>
              <a:chExt cx="836762" cy="457201"/>
            </a:xfrm>
          </p:grpSpPr>
          <p:sp>
            <p:nvSpPr>
              <p:cNvPr id="33" name="Oval 32"/>
              <p:cNvSpPr/>
              <p:nvPr/>
            </p:nvSpPr>
            <p:spPr>
              <a:xfrm>
                <a:off x="7782351" y="381572"/>
                <a:ext cx="836762" cy="457201"/>
              </a:xfrm>
              <a:prstGeom prst="ellipse">
                <a:avLst/>
              </a:prstGeom>
            </p:spPr>
            <p:style>
              <a:lnRef idx="2">
                <a:schemeClr val="accent4">
                  <a:shade val="50000"/>
                </a:schemeClr>
              </a:lnRef>
              <a:fillRef idx="1">
                <a:schemeClr val="accent4"/>
              </a:fillRef>
              <a:effectRef idx="0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4" name="Straight Arrow Connector 33"/>
              <p:cNvCxnSpPr/>
              <p:nvPr/>
            </p:nvCxnSpPr>
            <p:spPr>
              <a:xfrm flipV="1">
                <a:off x="8131720" y="439704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/>
              <p:cNvCxnSpPr/>
              <p:nvPr/>
            </p:nvCxnSpPr>
            <p:spPr>
              <a:xfrm flipV="1">
                <a:off x="8274769" y="439704"/>
                <a:ext cx="1" cy="271917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5224167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3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61626E63-B707-459A-A073-2EE6250BCA52}"/>
</file>

<file path=customXml/itemProps2.xml><?xml version="1.0" encoding="utf-8"?>
<ds:datastoreItem xmlns:ds="http://schemas.openxmlformats.org/officeDocument/2006/customXml" ds:itemID="{D509E3E8-3B6C-42F4-BEDF-6C9F8B3C6DC7}"/>
</file>

<file path=customXml/itemProps3.xml><?xml version="1.0" encoding="utf-8"?>
<ds:datastoreItem xmlns:ds="http://schemas.openxmlformats.org/officeDocument/2006/customXml" ds:itemID="{427BEB49-1233-4545-A25B-47553F891FE6}"/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107</TotalTime>
  <Words>501</Words>
  <Application>Microsoft Office PowerPoint</Application>
  <PresentationFormat>Widescreen</PresentationFormat>
  <Paragraphs>59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3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USTAFA ELDAKAK</dc:creator>
  <cp:lastModifiedBy>Aayudh</cp:lastModifiedBy>
  <cp:revision>560</cp:revision>
  <dcterms:created xsi:type="dcterms:W3CDTF">2014-02-12T16:42:52Z</dcterms:created>
  <dcterms:modified xsi:type="dcterms:W3CDTF">2015-11-22T23:20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